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57" r:id="rId2"/>
    <p:sldId id="258" r:id="rId3"/>
    <p:sldId id="259" r:id="rId4"/>
  </p:sldIdLst>
  <p:sldSz cx="6858000" cy="800417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10" d="100"/>
          <a:sy n="110" d="100"/>
        </p:scale>
        <p:origin x="-930" y="2502"/>
      </p:cViewPr>
      <p:guideLst>
        <p:guide orient="horz" pos="2521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960BB54-5BB7-4DF6-A59E-64B8E1C41922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960563" y="685800"/>
            <a:ext cx="29368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229721D-B9B2-4811-BE5F-FF537B9A9735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229721D-B9B2-4811-BE5F-FF537B9A9735}" type="slidenum">
              <a:rPr lang="zh-CN" altLang="en-US" smtClean="0"/>
              <a:pPr/>
              <a:t>1</a:t>
            </a:fld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486483"/>
            <a:ext cx="5829300" cy="1715710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4535699"/>
            <a:ext cx="4800600" cy="2045511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374270"/>
            <a:ext cx="1157288" cy="7970824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374270"/>
            <a:ext cx="3357563" cy="7970824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143424"/>
            <a:ext cx="5829300" cy="158971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392511"/>
            <a:ext cx="5829300" cy="1750913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2178914"/>
            <a:ext cx="2257425" cy="61661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2178914"/>
            <a:ext cx="2257425" cy="6166179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20538"/>
            <a:ext cx="6172200" cy="1334029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1791676"/>
            <a:ext cx="3030141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538361"/>
            <a:ext cx="3030141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1791676"/>
            <a:ext cx="3031331" cy="74668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538361"/>
            <a:ext cx="3031331" cy="461166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18685"/>
            <a:ext cx="2256235" cy="135626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18685"/>
            <a:ext cx="3833813" cy="6831342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674948"/>
            <a:ext cx="2256235" cy="547507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5602922"/>
            <a:ext cx="4114800" cy="66145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715188"/>
            <a:ext cx="4114800" cy="480250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6264379"/>
            <a:ext cx="4114800" cy="9393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20538"/>
            <a:ext cx="6172200" cy="133402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1867641"/>
            <a:ext cx="6172200" cy="52823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7418685"/>
            <a:ext cx="1600200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0743DD7-9907-4757-B93D-CE9BE46F65AD}" type="datetimeFigureOut">
              <a:rPr lang="zh-CN" altLang="en-US" smtClean="0"/>
              <a:pPr/>
              <a:t>2017/5/2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7418685"/>
            <a:ext cx="2171700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7418685"/>
            <a:ext cx="1600200" cy="42614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1C0692-08DD-41E5-9471-4F932405B936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研究生\神经生物学\课题\图片结果\7721文章\7721 hela DNA胶照片\2017-5-18 7721 CDC42 WASL RHO SUB1 2.tif"/>
          <p:cNvPicPr>
            <a:picLocks noChangeAspect="1" noChangeArrowheads="1"/>
          </p:cNvPicPr>
          <p:nvPr/>
        </p:nvPicPr>
        <p:blipFill>
          <a:blip r:embed="rId3" cstate="print"/>
          <a:srcRect l="34291" t="39165" r="28130" b="31470"/>
          <a:stretch>
            <a:fillRect/>
          </a:stretch>
        </p:blipFill>
        <p:spPr bwMode="auto">
          <a:xfrm>
            <a:off x="526169" y="1294746"/>
            <a:ext cx="2534682" cy="1584176"/>
          </a:xfrm>
          <a:prstGeom prst="rect">
            <a:avLst/>
          </a:prstGeom>
          <a:noFill/>
        </p:spPr>
      </p:pic>
      <p:sp>
        <p:nvSpPr>
          <p:cNvPr id="3" name="TextBox 2"/>
          <p:cNvSpPr txBox="1"/>
          <p:nvPr/>
        </p:nvSpPr>
        <p:spPr>
          <a:xfrm rot="18318655">
            <a:off x="502897" y="102727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 rot="18318655">
            <a:off x="561552" y="865904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Picture 3" descr="E:\研究生\神经生物学\课题\图片结果\7721文章\7721 hela DNA胶照片\2017-5-18 7721 CTNNB1 ACTB ATP11A TMEM30A.tif"/>
          <p:cNvPicPr>
            <a:picLocks noChangeAspect="1" noChangeArrowheads="1"/>
          </p:cNvPicPr>
          <p:nvPr/>
        </p:nvPicPr>
        <p:blipFill>
          <a:blip r:embed="rId4" cstate="print"/>
          <a:srcRect l="23757" t="28211" r="20881" b="32567"/>
          <a:stretch>
            <a:fillRect/>
          </a:stretch>
        </p:blipFill>
        <p:spPr bwMode="auto">
          <a:xfrm>
            <a:off x="3685556" y="1276816"/>
            <a:ext cx="2795605" cy="1584176"/>
          </a:xfrm>
          <a:prstGeom prst="rect">
            <a:avLst/>
          </a:prstGeom>
          <a:noFill/>
        </p:spPr>
      </p:pic>
      <p:pic>
        <p:nvPicPr>
          <p:cNvPr id="8" name="Picture 4" descr="E:\研究生\神经生物学\课题\图片结果\7721文章\7721 hela DNA胶照片\2017-5-18 7721 HeLa SRC.tif"/>
          <p:cNvPicPr>
            <a:picLocks noChangeAspect="1" noChangeArrowheads="1"/>
          </p:cNvPicPr>
          <p:nvPr/>
        </p:nvPicPr>
        <p:blipFill>
          <a:blip r:embed="rId5" cstate="print"/>
          <a:srcRect l="31010" t="30511" r="29702" b="32011"/>
          <a:stretch>
            <a:fillRect/>
          </a:stretch>
        </p:blipFill>
        <p:spPr bwMode="auto">
          <a:xfrm>
            <a:off x="692696" y="4658110"/>
            <a:ext cx="2160240" cy="1648233"/>
          </a:xfrm>
          <a:prstGeom prst="rect">
            <a:avLst/>
          </a:prstGeom>
          <a:noFill/>
        </p:spPr>
      </p:pic>
      <p:pic>
        <p:nvPicPr>
          <p:cNvPr id="10" name="Picture 5" descr="E:\研究生\神经生物学\课题\图片结果\7721文章\7721 hela DNA胶照片\2017-5-18 7721 SLC2A1 HSP90B1 CLTC SRC -2.tif"/>
          <p:cNvPicPr>
            <a:picLocks noChangeAspect="1" noChangeArrowheads="1"/>
          </p:cNvPicPr>
          <p:nvPr/>
        </p:nvPicPr>
        <p:blipFill>
          <a:blip r:embed="rId6" cstate="print"/>
          <a:srcRect l="30441" t="34279" r="38188" b="33420"/>
          <a:stretch>
            <a:fillRect/>
          </a:stretch>
        </p:blipFill>
        <p:spPr bwMode="auto">
          <a:xfrm>
            <a:off x="4189612" y="4671338"/>
            <a:ext cx="2160240" cy="1779021"/>
          </a:xfrm>
          <a:prstGeom prst="rect">
            <a:avLst/>
          </a:prstGeom>
          <a:noFill/>
        </p:spPr>
      </p:pic>
      <p:sp>
        <p:nvSpPr>
          <p:cNvPr id="12" name="TextBox 11"/>
          <p:cNvSpPr txBox="1"/>
          <p:nvPr/>
        </p:nvSpPr>
        <p:spPr>
          <a:xfrm>
            <a:off x="85156" y="178145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94121" y="186184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5156" y="194310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85156" y="202407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85156" y="208770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5156" y="216867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85156" y="224935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318655">
            <a:off x="775274" y="103627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8318655">
            <a:off x="907021" y="1039443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318655">
            <a:off x="967913" y="909219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318655">
            <a:off x="1118566" y="854871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318655">
            <a:off x="1332288" y="102523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8318655">
            <a:off x="1464035" y="102841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8318655">
            <a:off x="1524927" y="898186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8318655">
            <a:off x="1675580" y="854871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8318655">
            <a:off x="1889302" y="102523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8318655">
            <a:off x="2021049" y="102841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8318655">
            <a:off x="2081941" y="898186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 rot="18318655">
            <a:off x="2223069" y="859532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 rot="18318655">
            <a:off x="2436791" y="1029900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 rot="18318655">
            <a:off x="2568538" y="1033071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 rot="18318655">
            <a:off x="2629430" y="90284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4" name="右大括号 33"/>
          <p:cNvSpPr/>
          <p:nvPr/>
        </p:nvSpPr>
        <p:spPr>
          <a:xfrm rot="5400000">
            <a:off x="913248" y="2813955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5" name="TextBox 34"/>
          <p:cNvSpPr txBox="1"/>
          <p:nvPr/>
        </p:nvSpPr>
        <p:spPr>
          <a:xfrm>
            <a:off x="709047" y="3137991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CDC42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右大括号 36"/>
          <p:cNvSpPr/>
          <p:nvPr/>
        </p:nvSpPr>
        <p:spPr>
          <a:xfrm rot="5400000">
            <a:off x="1428678" y="2810204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右大括号 37"/>
          <p:cNvSpPr/>
          <p:nvPr/>
        </p:nvSpPr>
        <p:spPr>
          <a:xfrm rot="5400000">
            <a:off x="1964538" y="2813955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9" name="右大括号 38"/>
          <p:cNvSpPr/>
          <p:nvPr/>
        </p:nvSpPr>
        <p:spPr>
          <a:xfrm rot="5400000">
            <a:off x="2524700" y="2813955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0" name="TextBox 39"/>
          <p:cNvSpPr txBox="1"/>
          <p:nvPr/>
        </p:nvSpPr>
        <p:spPr>
          <a:xfrm>
            <a:off x="1252483" y="3137991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WASL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1780841" y="3137991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RHO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2341003" y="3137991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SU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764704" y="34260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2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>
            <a:off x="1332817" y="34260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7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1846948" y="342602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>
            <a:off x="2448467" y="3426023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85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8318655">
            <a:off x="3722900" y="1003426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8318655">
            <a:off x="3797457" y="857953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 rot="18318655">
            <a:off x="4027081" y="101241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 rot="18318655">
            <a:off x="4142926" y="1023541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 rot="18318655">
            <a:off x="4219720" y="885366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8318655">
            <a:off x="4362422" y="854871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8318655">
            <a:off x="4576144" y="100138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8318655">
            <a:off x="4699940" y="1004557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318655">
            <a:off x="4792636" y="874333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8318655">
            <a:off x="5117256" y="100138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 rot="18318655">
            <a:off x="5249003" y="1004557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 rot="18318655">
            <a:off x="5341699" y="874333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 rot="18318655">
            <a:off x="5607659" y="835679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 rot="18318655">
            <a:off x="5811914" y="100604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 rot="18318655">
            <a:off x="5945449" y="102512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8318655">
            <a:off x="6006948" y="878994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TextBox 63"/>
          <p:cNvSpPr txBox="1"/>
          <p:nvPr/>
        </p:nvSpPr>
        <p:spPr>
          <a:xfrm rot="18318655">
            <a:off x="4913232" y="88491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3231526" y="170578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3240491" y="178617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3231526" y="186743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3231526" y="194840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3231526" y="201203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3231526" y="209300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3231526" y="217368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右大括号 71"/>
          <p:cNvSpPr/>
          <p:nvPr/>
        </p:nvSpPr>
        <p:spPr>
          <a:xfrm rot="5400000">
            <a:off x="4081600" y="2745698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3" name="TextBox 72"/>
          <p:cNvSpPr txBox="1"/>
          <p:nvPr/>
        </p:nvSpPr>
        <p:spPr>
          <a:xfrm>
            <a:off x="3877399" y="3069734"/>
            <a:ext cx="67518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CTNN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4" name="右大括号 73"/>
          <p:cNvSpPr/>
          <p:nvPr/>
        </p:nvSpPr>
        <p:spPr>
          <a:xfrm rot="5400000">
            <a:off x="4943268" y="2471917"/>
            <a:ext cx="252028" cy="100811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6" name="右大括号 75"/>
          <p:cNvSpPr/>
          <p:nvPr/>
        </p:nvSpPr>
        <p:spPr>
          <a:xfrm rot="5400000">
            <a:off x="5940880" y="2745698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77" name="TextBox 76"/>
          <p:cNvSpPr txBox="1"/>
          <p:nvPr/>
        </p:nvSpPr>
        <p:spPr>
          <a:xfrm>
            <a:off x="4741120" y="3069734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ATP11A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757183" y="3069734"/>
            <a:ext cx="755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TMEM30A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4005064" y="3357766"/>
            <a:ext cx="4320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99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4853258" y="3357766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0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864647" y="3357766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91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 rot="18318655">
            <a:off x="738768" y="4405283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 rot="18318655">
            <a:off x="805374" y="4243908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 rot="18318655">
            <a:off x="1027047" y="4406325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 rot="18318655">
            <a:off x="1166745" y="4417447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 rot="18318655">
            <a:off x="1251490" y="4279272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 rot="18318655">
            <a:off x="1394192" y="4232875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 rot="18318655">
            <a:off x="1607914" y="4403243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 rot="18318655">
            <a:off x="1763514" y="4406414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 rot="18318655">
            <a:off x="1824406" y="4276190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>
            <a:off x="263296" y="497492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>
            <a:off x="272261" y="505531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>
            <a:off x="263296" y="513657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263296" y="521755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263296" y="528117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263296" y="536214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263296" y="544282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右大括号 114"/>
          <p:cNvSpPr/>
          <p:nvPr/>
        </p:nvSpPr>
        <p:spPr>
          <a:xfrm rot="5400000">
            <a:off x="1111098" y="6188436"/>
            <a:ext cx="252028" cy="495344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6" name="TextBox 115"/>
          <p:cNvSpPr txBox="1"/>
          <p:nvPr/>
        </p:nvSpPr>
        <p:spPr>
          <a:xfrm>
            <a:off x="861447" y="6526118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 SRC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右大括号 116"/>
          <p:cNvSpPr/>
          <p:nvPr/>
        </p:nvSpPr>
        <p:spPr>
          <a:xfrm rot="5400000">
            <a:off x="1687844" y="6175291"/>
            <a:ext cx="252028" cy="514131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9" name="TextBox 118"/>
          <p:cNvSpPr txBox="1"/>
          <p:nvPr/>
        </p:nvSpPr>
        <p:spPr>
          <a:xfrm>
            <a:off x="1540050" y="6526118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 SRC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988663" y="681415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61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1654777" y="681415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61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764289" y="523084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5" name="TextBox 124"/>
          <p:cNvSpPr txBox="1"/>
          <p:nvPr/>
        </p:nvSpPr>
        <p:spPr>
          <a:xfrm>
            <a:off x="3773254" y="531123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3764289" y="539249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3764289" y="547347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8" name="TextBox 127"/>
          <p:cNvSpPr txBox="1"/>
          <p:nvPr/>
        </p:nvSpPr>
        <p:spPr>
          <a:xfrm>
            <a:off x="3764289" y="553709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3764289" y="561806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3764289" y="569874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1" name="TextBox 130"/>
          <p:cNvSpPr txBox="1"/>
          <p:nvPr/>
        </p:nvSpPr>
        <p:spPr>
          <a:xfrm rot="18318655">
            <a:off x="4284041" y="4411655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2" name="TextBox 131"/>
          <p:cNvSpPr txBox="1"/>
          <p:nvPr/>
        </p:nvSpPr>
        <p:spPr>
          <a:xfrm rot="18318655">
            <a:off x="4350647" y="4250280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3" name="TextBox 132"/>
          <p:cNvSpPr txBox="1"/>
          <p:nvPr/>
        </p:nvSpPr>
        <p:spPr>
          <a:xfrm rot="18318655">
            <a:off x="4548467" y="441269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 rot="18318655">
            <a:off x="4688165" y="4423819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 rot="18318655">
            <a:off x="4749057" y="4285644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 rot="18318655">
            <a:off x="4883808" y="4239247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7" name="TextBox 136"/>
          <p:cNvSpPr txBox="1"/>
          <p:nvPr/>
        </p:nvSpPr>
        <p:spPr>
          <a:xfrm rot="18318655">
            <a:off x="5105481" y="4409615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8" name="TextBox 137"/>
          <p:cNvSpPr txBox="1"/>
          <p:nvPr/>
        </p:nvSpPr>
        <p:spPr>
          <a:xfrm rot="18318655">
            <a:off x="5229277" y="4412786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9" name="TextBox 138"/>
          <p:cNvSpPr txBox="1"/>
          <p:nvPr/>
        </p:nvSpPr>
        <p:spPr>
          <a:xfrm rot="18318655">
            <a:off x="5314022" y="4282562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0" name="TextBox 139"/>
          <p:cNvSpPr txBox="1"/>
          <p:nvPr/>
        </p:nvSpPr>
        <p:spPr>
          <a:xfrm rot="18318655">
            <a:off x="5467374" y="4254700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1" name="TextBox 140"/>
          <p:cNvSpPr txBox="1"/>
          <p:nvPr/>
        </p:nvSpPr>
        <p:spPr>
          <a:xfrm rot="18318655">
            <a:off x="5689047" y="439326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2" name="TextBox 141"/>
          <p:cNvSpPr txBox="1"/>
          <p:nvPr/>
        </p:nvSpPr>
        <p:spPr>
          <a:xfrm rot="18318655">
            <a:off x="5812843" y="4396435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 rot="18318655">
            <a:off x="5897588" y="4266211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4" name="右大括号 143"/>
          <p:cNvSpPr/>
          <p:nvPr/>
        </p:nvSpPr>
        <p:spPr>
          <a:xfrm rot="5400000">
            <a:off x="4689357" y="6354265"/>
            <a:ext cx="252028" cy="46848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5" name="TextBox 144"/>
          <p:cNvSpPr txBox="1"/>
          <p:nvPr/>
        </p:nvSpPr>
        <p:spPr>
          <a:xfrm>
            <a:off x="4426277" y="6678518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SLC2A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6" name="右大括号 145"/>
          <p:cNvSpPr/>
          <p:nvPr/>
        </p:nvSpPr>
        <p:spPr>
          <a:xfrm rot="5400000">
            <a:off x="5269172" y="6350948"/>
            <a:ext cx="252028" cy="46761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47" name="TextBox 146"/>
          <p:cNvSpPr txBox="1"/>
          <p:nvPr/>
        </p:nvSpPr>
        <p:spPr>
          <a:xfrm>
            <a:off x="5065125" y="6678518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SP90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8" name="TextBox 147"/>
          <p:cNvSpPr txBox="1"/>
          <p:nvPr/>
        </p:nvSpPr>
        <p:spPr>
          <a:xfrm>
            <a:off x="4553493" y="6966550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260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5179852" y="6966550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379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0" name="右大括号 149"/>
          <p:cNvSpPr/>
          <p:nvPr/>
        </p:nvSpPr>
        <p:spPr>
          <a:xfrm rot="5400000">
            <a:off x="5805481" y="6342565"/>
            <a:ext cx="252028" cy="46761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51" name="TextBox 150"/>
          <p:cNvSpPr txBox="1"/>
          <p:nvPr/>
        </p:nvSpPr>
        <p:spPr>
          <a:xfrm>
            <a:off x="5636946" y="6682285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CLTC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5757109" y="697031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3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E:\研究生\神经生物学\课题\图片结果\7721文章\7721 hela DNA胶照片\2017-5-18 HeLa CDC42 WASL RHO.tif"/>
          <p:cNvPicPr>
            <a:picLocks noChangeAspect="1" noChangeArrowheads="1"/>
          </p:cNvPicPr>
          <p:nvPr/>
        </p:nvPicPr>
        <p:blipFill>
          <a:blip r:embed="rId2" cstate="print"/>
          <a:srcRect l="31963" t="33119" r="27439" b="27659"/>
          <a:stretch>
            <a:fillRect/>
          </a:stretch>
        </p:blipFill>
        <p:spPr bwMode="auto">
          <a:xfrm>
            <a:off x="480908" y="1121767"/>
            <a:ext cx="2376264" cy="1836204"/>
          </a:xfrm>
          <a:prstGeom prst="rect">
            <a:avLst/>
          </a:prstGeom>
          <a:noFill/>
        </p:spPr>
      </p:pic>
      <p:pic>
        <p:nvPicPr>
          <p:cNvPr id="4" name="Picture 3" descr="E:\研究生\神经生物学\课题\图片结果\7721文章\7721 hela DNA胶照片\2017-5-18 HeLa SLC2A1 ATP11A ATCB TMEM30A.tif"/>
          <p:cNvPicPr>
            <a:picLocks noChangeAspect="1" noChangeArrowheads="1"/>
          </p:cNvPicPr>
          <p:nvPr/>
        </p:nvPicPr>
        <p:blipFill>
          <a:blip r:embed="rId3" cstate="print"/>
          <a:srcRect l="20278" t="25098" r="22515" b="35680"/>
          <a:stretch>
            <a:fillRect/>
          </a:stretch>
        </p:blipFill>
        <p:spPr bwMode="auto">
          <a:xfrm>
            <a:off x="3721268" y="1193775"/>
            <a:ext cx="3020100" cy="1656184"/>
          </a:xfrm>
          <a:prstGeom prst="rect">
            <a:avLst/>
          </a:prstGeom>
          <a:noFill/>
        </p:spPr>
      </p:pic>
      <p:pic>
        <p:nvPicPr>
          <p:cNvPr id="6" name="Picture 4" descr="E:\研究生\神经生物学\课题\图片结果\7721文章\7721 hela DNA胶照片\2017-5-18 HeLa SUB1 CTNNB1 HSP90B1.tif"/>
          <p:cNvPicPr>
            <a:picLocks noChangeAspect="1" noChangeArrowheads="1"/>
          </p:cNvPicPr>
          <p:nvPr/>
        </p:nvPicPr>
        <p:blipFill>
          <a:blip r:embed="rId4" cstate="print"/>
          <a:srcRect l="24560" t="34006" r="34360" b="28477"/>
          <a:stretch>
            <a:fillRect/>
          </a:stretch>
        </p:blipFill>
        <p:spPr bwMode="auto">
          <a:xfrm>
            <a:off x="480908" y="4805208"/>
            <a:ext cx="2168712" cy="1584176"/>
          </a:xfrm>
          <a:prstGeom prst="rect">
            <a:avLst/>
          </a:prstGeom>
          <a:noFill/>
        </p:spPr>
      </p:pic>
      <p:sp>
        <p:nvSpPr>
          <p:cNvPr id="11" name="TextBox 10"/>
          <p:cNvSpPr txBox="1"/>
          <p:nvPr/>
        </p:nvSpPr>
        <p:spPr>
          <a:xfrm rot="18318655">
            <a:off x="566177" y="851459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 rot="18318655">
            <a:off x="648685" y="705986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8318655">
            <a:off x="886260" y="852501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 rot="18318655">
            <a:off x="1040505" y="863623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 rot="18318655">
            <a:off x="1126605" y="725448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 rot="18318655">
            <a:off x="1279228" y="702904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 rot="18318655">
            <a:off x="1507336" y="84941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8318655">
            <a:off x="1672675" y="85259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8318655">
            <a:off x="1753377" y="722366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 rot="18318655">
            <a:off x="1919349" y="694504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318655">
            <a:off x="2147457" y="856921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318655">
            <a:off x="2304845" y="868043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318655">
            <a:off x="2401449" y="706015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4624" y="173758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3589" y="181797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44624" y="189924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44624" y="1980213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44624" y="204383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44624" y="212480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44624" y="220548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右大括号 30"/>
          <p:cNvSpPr/>
          <p:nvPr/>
        </p:nvSpPr>
        <p:spPr>
          <a:xfrm rot="5400000">
            <a:off x="1020504" y="2845780"/>
            <a:ext cx="252028" cy="532515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TextBox 31"/>
          <p:cNvSpPr txBox="1"/>
          <p:nvPr/>
        </p:nvSpPr>
        <p:spPr>
          <a:xfrm>
            <a:off x="836712" y="3202048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ACTB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右大括号 32"/>
          <p:cNvSpPr/>
          <p:nvPr/>
        </p:nvSpPr>
        <p:spPr>
          <a:xfrm rot="5400000">
            <a:off x="1634665" y="2808118"/>
            <a:ext cx="252028" cy="60033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TextBox 33"/>
          <p:cNvSpPr txBox="1"/>
          <p:nvPr/>
        </p:nvSpPr>
        <p:spPr>
          <a:xfrm>
            <a:off x="1432023" y="320204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WASL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926746" y="3490080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 143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556792" y="3490080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7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7" name="右大括号 36"/>
          <p:cNvSpPr/>
          <p:nvPr/>
        </p:nvSpPr>
        <p:spPr>
          <a:xfrm rot="5400000">
            <a:off x="2290688" y="2807686"/>
            <a:ext cx="252028" cy="584435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8" name="TextBox 37"/>
          <p:cNvSpPr txBox="1"/>
          <p:nvPr/>
        </p:nvSpPr>
        <p:spPr>
          <a:xfrm>
            <a:off x="2063744" y="3205815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RHO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183907" y="349384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8318655">
            <a:off x="3845596" y="924597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8318655">
            <a:off x="3920153" y="763222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8318655">
            <a:off x="4133875" y="933590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 rot="18318655">
            <a:off x="4289475" y="936761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8318655">
            <a:off x="4358318" y="80653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8318655">
            <a:off x="4508971" y="752189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8318655">
            <a:off x="4714742" y="922557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 rot="18318655">
            <a:off x="4854440" y="925728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 rot="18318655">
            <a:off x="4931234" y="795504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 rot="18318655">
            <a:off x="5775528" y="756850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 rot="18318655">
            <a:off x="6011587" y="927218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 rot="18318655">
            <a:off x="6177375" y="930389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 rot="18318655">
            <a:off x="6217873" y="800165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3284984" y="152663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293949" y="160702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3284984" y="168828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3284984" y="176925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3284984" y="183288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284984" y="191385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>
            <a:off x="3284984" y="199453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4" name="右大括号 63"/>
          <p:cNvSpPr/>
          <p:nvPr/>
        </p:nvSpPr>
        <p:spPr>
          <a:xfrm rot="5400000">
            <a:off x="4261620" y="2757400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5" name="TextBox 64"/>
          <p:cNvSpPr txBox="1"/>
          <p:nvPr/>
        </p:nvSpPr>
        <p:spPr>
          <a:xfrm>
            <a:off x="4053293" y="3081436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SLC2A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6" name="右大括号 65"/>
          <p:cNvSpPr/>
          <p:nvPr/>
        </p:nvSpPr>
        <p:spPr>
          <a:xfrm rot="5400000">
            <a:off x="4840658" y="2753649"/>
            <a:ext cx="252028" cy="468052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8" name="右大括号 67"/>
          <p:cNvSpPr/>
          <p:nvPr/>
        </p:nvSpPr>
        <p:spPr>
          <a:xfrm rot="5400000">
            <a:off x="6133275" y="2725371"/>
            <a:ext cx="252028" cy="53210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9" name="TextBox 68"/>
          <p:cNvSpPr txBox="1"/>
          <p:nvPr/>
        </p:nvSpPr>
        <p:spPr>
          <a:xfrm>
            <a:off x="4645259" y="3081436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ATP11A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5941403" y="3081436"/>
            <a:ext cx="78418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TMEM30A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4132803" y="3369468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260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4783374" y="3369468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0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6048867" y="3369468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91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18318655">
            <a:off x="534373" y="4542851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 rot="18318655">
            <a:off x="600979" y="4381476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 rot="18318655">
            <a:off x="822652" y="4543893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 rot="18318655">
            <a:off x="962350" y="4555015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 rot="18318655">
            <a:off x="1031193" y="4416840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1" name="TextBox 80"/>
          <p:cNvSpPr txBox="1"/>
          <p:nvPr/>
        </p:nvSpPr>
        <p:spPr>
          <a:xfrm rot="18318655">
            <a:off x="1165944" y="4386345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rot="18318655">
            <a:off x="1403519" y="4540811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8318655">
            <a:off x="1559119" y="4543982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 rot="18318655">
            <a:off x="1620011" y="4413758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 rot="18318655">
            <a:off x="1765246" y="4366912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 rot="18318655">
            <a:off x="1963066" y="4529329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 rot="18318655">
            <a:off x="2118666" y="4532500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8" name="TextBox 87"/>
          <p:cNvSpPr txBox="1"/>
          <p:nvPr/>
        </p:nvSpPr>
        <p:spPr>
          <a:xfrm rot="18318655">
            <a:off x="2179558" y="4402276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36673" y="526295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53589" y="534334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44624" y="5424610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4624" y="5505583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44624" y="556920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44624" y="565017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44624" y="573085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6" name="右大括号 95"/>
          <p:cNvSpPr/>
          <p:nvPr/>
        </p:nvSpPr>
        <p:spPr>
          <a:xfrm rot="5400000">
            <a:off x="908519" y="6293975"/>
            <a:ext cx="252028" cy="468486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7" name="TextBox 96"/>
          <p:cNvSpPr txBox="1"/>
          <p:nvPr/>
        </p:nvSpPr>
        <p:spPr>
          <a:xfrm>
            <a:off x="645439" y="6618228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CLTC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8" name="右大括号 97"/>
          <p:cNvSpPr/>
          <p:nvPr/>
        </p:nvSpPr>
        <p:spPr>
          <a:xfrm rot="5400000">
            <a:off x="1488334" y="6290658"/>
            <a:ext cx="252028" cy="46761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9" name="TextBox 98"/>
          <p:cNvSpPr txBox="1"/>
          <p:nvPr/>
        </p:nvSpPr>
        <p:spPr>
          <a:xfrm>
            <a:off x="1252483" y="661822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CTNN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772655" y="6906260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13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399014" y="690626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99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2" name="右大括号 101"/>
          <p:cNvSpPr/>
          <p:nvPr/>
        </p:nvSpPr>
        <p:spPr>
          <a:xfrm rot="5400000">
            <a:off x="2106686" y="6255889"/>
            <a:ext cx="252028" cy="520390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03" name="TextBox 102"/>
          <p:cNvSpPr txBox="1"/>
          <p:nvPr/>
        </p:nvSpPr>
        <p:spPr>
          <a:xfrm>
            <a:off x="1911765" y="6621995"/>
            <a:ext cx="74571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HSP90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2031928" y="6910027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379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05" name="图片 104" descr="2017-5-21 HeLa CLTC SRC SRC.tif"/>
          <p:cNvPicPr>
            <a:picLocks noChangeAspect="1"/>
          </p:cNvPicPr>
          <p:nvPr/>
        </p:nvPicPr>
        <p:blipFill>
          <a:blip r:embed="rId5" cstate="print"/>
          <a:srcRect l="27685" t="27685" r="31710" b="35401"/>
          <a:stretch>
            <a:fillRect/>
          </a:stretch>
        </p:blipFill>
        <p:spPr>
          <a:xfrm>
            <a:off x="3789040" y="4650159"/>
            <a:ext cx="2574285" cy="1872208"/>
          </a:xfrm>
          <a:prstGeom prst="rect">
            <a:avLst/>
          </a:prstGeom>
        </p:spPr>
      </p:pic>
      <p:sp>
        <p:nvSpPr>
          <p:cNvPr id="107" name="TextBox 106"/>
          <p:cNvSpPr txBox="1"/>
          <p:nvPr/>
        </p:nvSpPr>
        <p:spPr>
          <a:xfrm rot="18318655">
            <a:off x="3848845" y="4382874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8" name="TextBox 107"/>
          <p:cNvSpPr txBox="1"/>
          <p:nvPr/>
        </p:nvSpPr>
        <p:spPr>
          <a:xfrm rot="18318655">
            <a:off x="3971108" y="4221499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9" name="TextBox 108"/>
          <p:cNvSpPr txBox="1"/>
          <p:nvPr/>
        </p:nvSpPr>
        <p:spPr>
          <a:xfrm rot="18318655">
            <a:off x="4224585" y="438391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0" name="TextBox 109"/>
          <p:cNvSpPr txBox="1"/>
          <p:nvPr/>
        </p:nvSpPr>
        <p:spPr>
          <a:xfrm rot="18318655">
            <a:off x="4372234" y="4395038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 rot="18318655">
            <a:off x="4497183" y="4256863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3348592" y="5126311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3365508" y="520670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4" name="TextBox 113"/>
          <p:cNvSpPr txBox="1"/>
          <p:nvPr/>
        </p:nvSpPr>
        <p:spPr>
          <a:xfrm>
            <a:off x="3356543" y="528796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5" name="TextBox 114"/>
          <p:cNvSpPr txBox="1"/>
          <p:nvPr/>
        </p:nvSpPr>
        <p:spPr>
          <a:xfrm>
            <a:off x="3356543" y="536893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6" name="TextBox 115"/>
          <p:cNvSpPr txBox="1"/>
          <p:nvPr/>
        </p:nvSpPr>
        <p:spPr>
          <a:xfrm>
            <a:off x="3356543" y="5456414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7" name="TextBox 116"/>
          <p:cNvSpPr txBox="1"/>
          <p:nvPr/>
        </p:nvSpPr>
        <p:spPr>
          <a:xfrm>
            <a:off x="3356543" y="555328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8" name="TextBox 117"/>
          <p:cNvSpPr txBox="1"/>
          <p:nvPr/>
        </p:nvSpPr>
        <p:spPr>
          <a:xfrm>
            <a:off x="3356543" y="5689626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9" name="右大括号 118"/>
          <p:cNvSpPr/>
          <p:nvPr/>
        </p:nvSpPr>
        <p:spPr>
          <a:xfrm rot="5400000">
            <a:off x="4344560" y="6335933"/>
            <a:ext cx="252028" cy="642988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20" name="TextBox 119"/>
          <p:cNvSpPr txBox="1"/>
          <p:nvPr/>
        </p:nvSpPr>
        <p:spPr>
          <a:xfrm>
            <a:off x="4109774" y="6763338"/>
            <a:ext cx="7296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 SUB1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1" name="TextBox 120"/>
          <p:cNvSpPr txBox="1"/>
          <p:nvPr/>
        </p:nvSpPr>
        <p:spPr>
          <a:xfrm>
            <a:off x="4237888" y="7051370"/>
            <a:ext cx="42832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85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 descr="2017-5-21 HeLa GAPDH 7721 GAPDH.tif"/>
          <p:cNvPicPr>
            <a:picLocks noChangeAspect="1"/>
          </p:cNvPicPr>
          <p:nvPr/>
        </p:nvPicPr>
        <p:blipFill>
          <a:blip r:embed="rId2" cstate="print"/>
          <a:srcRect l="29531" t="20764" r="35401" b="40015"/>
          <a:stretch>
            <a:fillRect/>
          </a:stretch>
        </p:blipFill>
        <p:spPr>
          <a:xfrm>
            <a:off x="4077072" y="1121767"/>
            <a:ext cx="2160240" cy="1932847"/>
          </a:xfrm>
          <a:prstGeom prst="rect">
            <a:avLst/>
          </a:prstGeom>
        </p:spPr>
      </p:pic>
      <p:pic>
        <p:nvPicPr>
          <p:cNvPr id="3" name="图片 2" descr="2017-5-21 HeLa CDC42.tif"/>
          <p:cNvPicPr>
            <a:picLocks noChangeAspect="1"/>
          </p:cNvPicPr>
          <p:nvPr/>
        </p:nvPicPr>
        <p:blipFill>
          <a:blip r:embed="rId3" cstate="print"/>
          <a:srcRect l="35235" t="26929" r="46308" b="36157"/>
          <a:stretch>
            <a:fillRect/>
          </a:stretch>
        </p:blipFill>
        <p:spPr>
          <a:xfrm>
            <a:off x="908720" y="1121767"/>
            <a:ext cx="1224136" cy="1958618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 rot="18318655">
            <a:off x="985325" y="84698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 rot="18318655">
            <a:off x="1107588" y="685605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 rot="18318655">
            <a:off x="1361065" y="84802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8318655">
            <a:off x="1564371" y="859144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8318655">
            <a:off x="1673418" y="720969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476223" y="1564448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85188" y="164484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76223" y="172610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76223" y="1807075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476223" y="187069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476223" y="195167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6223" y="203235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右大括号 17"/>
          <p:cNvSpPr/>
          <p:nvPr/>
        </p:nvSpPr>
        <p:spPr>
          <a:xfrm rot="5400000">
            <a:off x="1551551" y="2920477"/>
            <a:ext cx="252028" cy="62254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9" name="TextBox 18"/>
          <p:cNvSpPr txBox="1"/>
          <p:nvPr/>
        </p:nvSpPr>
        <p:spPr>
          <a:xfrm>
            <a:off x="1322742" y="3321762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CDC42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1412776" y="3609794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 12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 rot="18318655">
            <a:off x="4142874" y="862882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8318655">
            <a:off x="4265137" y="701507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8318655">
            <a:off x="4518614" y="863924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8318655">
            <a:off x="4666263" y="875046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8318655">
            <a:off x="4767359" y="736871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8318655">
            <a:off x="4963318" y="694953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8318655">
            <a:off x="5216795" y="857370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8318655">
            <a:off x="5364444" y="868492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 rot="18318655">
            <a:off x="5465540" y="730317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1" name="右大括号 30"/>
          <p:cNvSpPr/>
          <p:nvPr/>
        </p:nvSpPr>
        <p:spPr>
          <a:xfrm rot="5400000">
            <a:off x="4688771" y="2906862"/>
            <a:ext cx="260310" cy="63399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2" name="TextBox 31"/>
          <p:cNvSpPr txBox="1"/>
          <p:nvPr/>
        </p:nvSpPr>
        <p:spPr>
          <a:xfrm>
            <a:off x="4479644" y="3309731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GAPDH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3" name="右大括号 32"/>
          <p:cNvSpPr/>
          <p:nvPr/>
        </p:nvSpPr>
        <p:spPr>
          <a:xfrm rot="5400000">
            <a:off x="5366025" y="2915801"/>
            <a:ext cx="252028" cy="600337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34" name="TextBox 33"/>
          <p:cNvSpPr txBox="1"/>
          <p:nvPr/>
        </p:nvSpPr>
        <p:spPr>
          <a:xfrm>
            <a:off x="4569678" y="3597763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 16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5268492" y="3597763"/>
            <a:ext cx="48603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68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5178008" y="3303273"/>
            <a:ext cx="70083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HeLa 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GAPDH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3647672" y="205210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3647672" y="218125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cxnSp>
        <p:nvCxnSpPr>
          <p:cNvPr id="47" name="直接箭头连接符 46"/>
          <p:cNvCxnSpPr/>
          <p:nvPr/>
        </p:nvCxnSpPr>
        <p:spPr>
          <a:xfrm flipH="1">
            <a:off x="4055864" y="2161629"/>
            <a:ext cx="21602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直接箭头连接符 47"/>
          <p:cNvCxnSpPr/>
          <p:nvPr/>
        </p:nvCxnSpPr>
        <p:spPr>
          <a:xfrm flipH="1">
            <a:off x="4051672" y="2307679"/>
            <a:ext cx="216024" cy="0"/>
          </a:xfrm>
          <a:prstGeom prst="straightConnector1">
            <a:avLst/>
          </a:prstGeom>
          <a:ln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8" name="图片 37" descr="2017-5-21 7721 ATP11ACLTC ACTB.tif"/>
          <p:cNvPicPr>
            <a:picLocks noChangeAspect="1"/>
          </p:cNvPicPr>
          <p:nvPr/>
        </p:nvPicPr>
        <p:blipFill>
          <a:blip r:embed="rId4" cstate="print"/>
          <a:srcRect l="27685" t="25378" r="29864" b="37708"/>
          <a:stretch>
            <a:fillRect/>
          </a:stretch>
        </p:blipFill>
        <p:spPr>
          <a:xfrm>
            <a:off x="836712" y="4684481"/>
            <a:ext cx="2587788" cy="1800200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rot="18318655">
            <a:off x="913588" y="4415620"/>
            <a:ext cx="4844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Marker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 rot="18318655">
            <a:off x="1713601" y="4254245"/>
            <a:ext cx="8691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Negative 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 rot="18318655">
            <a:off x="1246198" y="4416662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4" name="TextBox 43"/>
          <p:cNvSpPr txBox="1"/>
          <p:nvPr/>
        </p:nvSpPr>
        <p:spPr>
          <a:xfrm rot="18318655">
            <a:off x="1423626" y="4427784"/>
            <a:ext cx="5020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Vehicle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5" name="TextBox 44"/>
          <p:cNvSpPr txBox="1"/>
          <p:nvPr/>
        </p:nvSpPr>
        <p:spPr>
          <a:xfrm rot="18318655">
            <a:off x="1524047" y="4289609"/>
            <a:ext cx="82586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Overexpression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6" name="TextBox 45"/>
          <p:cNvSpPr txBox="1"/>
          <p:nvPr/>
        </p:nvSpPr>
        <p:spPr>
          <a:xfrm rot="18318655">
            <a:off x="1081515" y="4417466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Control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410290" y="5198858"/>
            <a:ext cx="49885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10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419255" y="5287877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7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1" name="TextBox 50"/>
          <p:cNvSpPr txBox="1"/>
          <p:nvPr/>
        </p:nvSpPr>
        <p:spPr>
          <a:xfrm>
            <a:off x="410290" y="5369138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5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410290" y="5450111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4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410290" y="5539612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3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410290" y="561195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2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410290" y="5692639"/>
            <a:ext cx="49244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800" dirty="0" smtClean="0">
                <a:latin typeface="Times New Roman" pitchFamily="18" charset="0"/>
                <a:cs typeface="Times New Roman" pitchFamily="18" charset="0"/>
              </a:rPr>
              <a:t>  100bp</a:t>
            </a:r>
            <a:endParaRPr lang="zh-CN" altLang="en-US" sz="8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6" name="右大括号 55"/>
          <p:cNvSpPr/>
          <p:nvPr/>
        </p:nvSpPr>
        <p:spPr>
          <a:xfrm rot="5400000">
            <a:off x="1488556" y="6259303"/>
            <a:ext cx="252028" cy="748539"/>
          </a:xfrm>
          <a:prstGeom prst="righ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7" name="TextBox 56"/>
          <p:cNvSpPr txBox="1"/>
          <p:nvPr/>
        </p:nvSpPr>
        <p:spPr>
          <a:xfrm>
            <a:off x="1274386" y="6723583"/>
            <a:ext cx="6559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7721 </a:t>
            </a:r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cells</a:t>
            </a:r>
          </a:p>
          <a:p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   </a:t>
            </a:r>
            <a:r>
              <a:rPr lang="en-US" altLang="zh-CN" sz="900" b="1" dirty="0" smtClean="0">
                <a:latin typeface="Times New Roman" pitchFamily="18" charset="0"/>
                <a:cs typeface="Times New Roman" pitchFamily="18" charset="0"/>
              </a:rPr>
              <a:t>ACTB</a:t>
            </a:r>
            <a:endParaRPr lang="zh-CN" altLang="en-US" sz="9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340768" y="7011615"/>
            <a:ext cx="51488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900" b="1" dirty="0" smtClean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rPr>
              <a:t>143bp</a:t>
            </a:r>
            <a:endParaRPr lang="zh-CN" altLang="en-US" sz="900" b="1" dirty="0">
              <a:solidFill>
                <a:srgbClr val="00B050"/>
              </a:solidFill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5</TotalTime>
  <Words>420</Words>
  <Application>Microsoft Office PowerPoint</Application>
  <PresentationFormat>自定义</PresentationFormat>
  <Paragraphs>271</Paragraphs>
  <Slides>3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Administrator</dc:creator>
  <cp:lastModifiedBy>Administrator</cp:lastModifiedBy>
  <cp:revision>29</cp:revision>
  <dcterms:created xsi:type="dcterms:W3CDTF">2017-05-19T14:04:58Z</dcterms:created>
  <dcterms:modified xsi:type="dcterms:W3CDTF">2017-05-22T15:07:04Z</dcterms:modified>
</cp:coreProperties>
</file>